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7" r:id="rId2"/>
    <p:sldId id="258" r:id="rId3"/>
    <p:sldId id="266" r:id="rId4"/>
    <p:sldId id="260" r:id="rId5"/>
    <p:sldId id="269" r:id="rId6"/>
    <p:sldId id="262" r:id="rId7"/>
    <p:sldId id="270" r:id="rId8"/>
    <p:sldId id="265" r:id="rId9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3" autoAdjust="0"/>
    <p:restoredTop sz="67665" autoAdjust="0"/>
  </p:normalViewPr>
  <p:slideViewPr>
    <p:cSldViewPr snapToGrid="0">
      <p:cViewPr>
        <p:scale>
          <a:sx n="84" d="100"/>
          <a:sy n="84" d="100"/>
        </p:scale>
        <p:origin x="3080" y="-29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81E2C2-398C-4C9D-AC54-E15F9777A1CD}" type="datetimeFigureOut">
              <a:rPr lang="en-US" smtClean="0"/>
              <a:t>10/7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B7C141-2C2E-475F-BF3F-B027405E82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7589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B7C141-2C2E-475F-BF3F-B027405E82E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57764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B7C141-2C2E-475F-BF3F-B027405E82E3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44228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995312"/>
            <a:ext cx="51435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ACAE8-D13F-4823-B1FE-64F176BD655F}" type="datetimeFigureOut">
              <a:rPr lang="en-US" smtClean="0"/>
              <a:t>10/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26B49-DC07-41F0-90D8-01EDB47FD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944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ACAE8-D13F-4823-B1FE-64F176BD655F}" type="datetimeFigureOut">
              <a:rPr lang="en-US" smtClean="0"/>
              <a:t>10/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26B49-DC07-41F0-90D8-01EDB47FD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3383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ACAE8-D13F-4823-B1FE-64F176BD655F}" type="datetimeFigureOut">
              <a:rPr lang="en-US" smtClean="0"/>
              <a:t>10/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26B49-DC07-41F0-90D8-01EDB47FD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8819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ACAE8-D13F-4823-B1FE-64F176BD655F}" type="datetimeFigureOut">
              <a:rPr lang="en-US" smtClean="0"/>
              <a:t>10/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26B49-DC07-41F0-90D8-01EDB47FD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112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5"/>
            <a:ext cx="5915025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6"/>
            <a:ext cx="5915025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>
                    <a:tint val="75000"/>
                  </a:schemeClr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ACAE8-D13F-4823-B1FE-64F176BD655F}" type="datetimeFigureOut">
              <a:rPr lang="en-US" smtClean="0"/>
              <a:t>10/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26B49-DC07-41F0-90D8-01EDB47FD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244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ACAE8-D13F-4823-B1FE-64F176BD655F}" type="datetimeFigureOut">
              <a:rPr lang="en-US" smtClean="0"/>
              <a:t>10/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26B49-DC07-41F0-90D8-01EDB47FD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311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2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ACAE8-D13F-4823-B1FE-64F176BD655F}" type="datetimeFigureOut">
              <a:rPr lang="en-US" smtClean="0"/>
              <a:t>10/7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26B49-DC07-41F0-90D8-01EDB47FD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1819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ACAE8-D13F-4823-B1FE-64F176BD655F}" type="datetimeFigureOut">
              <a:rPr lang="en-US" smtClean="0"/>
              <a:t>10/7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26B49-DC07-41F0-90D8-01EDB47FD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349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ACAE8-D13F-4823-B1FE-64F176BD655F}" type="datetimeFigureOut">
              <a:rPr lang="en-US" smtClean="0"/>
              <a:t>10/7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26B49-DC07-41F0-90D8-01EDB47FD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914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3"/>
            <a:ext cx="3471863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ACAE8-D13F-4823-B1FE-64F176BD655F}" type="datetimeFigureOut">
              <a:rPr lang="en-US" smtClean="0"/>
              <a:t>10/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26B49-DC07-41F0-90D8-01EDB47FD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3427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755423"/>
            <a:ext cx="3471863" cy="8664222"/>
          </a:xfrm>
        </p:spPr>
        <p:txBody>
          <a:bodyPr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ACAE8-D13F-4823-B1FE-64F176BD655F}" type="datetimeFigureOut">
              <a:rPr lang="en-US" smtClean="0"/>
              <a:t>10/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26B49-DC07-41F0-90D8-01EDB47FD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0045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2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6ACAE8-D13F-4823-B1FE-64F176BD655F}" type="datetimeFigureOut">
              <a:rPr lang="en-US" smtClean="0"/>
              <a:t>10/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79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F26B49-DC07-41F0-90D8-01EDB47FD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46480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emf"/><Relationship Id="rId4" Type="http://schemas.openxmlformats.org/officeDocument/2006/relationships/image" Target="../media/image14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10" Type="http://schemas.openxmlformats.org/officeDocument/2006/relationships/image" Target="../media/image24.png"/><Relationship Id="rId4" Type="http://schemas.openxmlformats.org/officeDocument/2006/relationships/image" Target="../media/image18.png"/><Relationship Id="rId9" Type="http://schemas.openxmlformats.org/officeDocument/2006/relationships/image" Target="../media/image2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e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8.emf"/><Relationship Id="rId5" Type="http://schemas.openxmlformats.org/officeDocument/2006/relationships/image" Target="../media/image37.emf"/><Relationship Id="rId4" Type="http://schemas.openxmlformats.org/officeDocument/2006/relationships/image" Target="../media/image3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1F93A8EB-C481-764D-A290-497D29D30CE0}"/>
              </a:ext>
            </a:extLst>
          </p:cNvPr>
          <p:cNvGrpSpPr/>
          <p:nvPr/>
        </p:nvGrpSpPr>
        <p:grpSpPr>
          <a:xfrm>
            <a:off x="424920" y="582857"/>
            <a:ext cx="6642630" cy="7951543"/>
            <a:chOff x="227866" y="468923"/>
            <a:chExt cx="7030184" cy="592015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87F9B997-D61C-EC49-95E8-8B9C67295D0C}"/>
                </a:ext>
              </a:extLst>
            </p:cNvPr>
            <p:cNvPicPr/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5215"/>
            <a:stretch/>
          </p:blipFill>
          <p:spPr>
            <a:xfrm>
              <a:off x="409967" y="950393"/>
              <a:ext cx="1773572" cy="1276992"/>
            </a:xfrm>
            <a:prstGeom prst="rect">
              <a:avLst/>
            </a:prstGeom>
          </p:spPr>
        </p:pic>
        <p:sp>
          <p:nvSpPr>
            <p:cNvPr id="6" name="TextBox 10">
              <a:extLst>
                <a:ext uri="{FF2B5EF4-FFF2-40B4-BE49-F238E27FC236}">
                  <a16:creationId xmlns:a16="http://schemas.microsoft.com/office/drawing/2014/main" id="{D9C452D6-7638-A641-82F6-92FF2178101B}"/>
                </a:ext>
              </a:extLst>
            </p:cNvPr>
            <p:cNvSpPr txBox="1"/>
            <p:nvPr/>
          </p:nvSpPr>
          <p:spPr>
            <a:xfrm>
              <a:off x="2545889" y="644374"/>
              <a:ext cx="1622238" cy="2062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ea typeface="Times New Roman" panose="02020603050405020304" pitchFamily="18" charset="0"/>
                  <a:cs typeface="Arial" panose="020B0604020202020204" pitchFamily="34" charset="0"/>
                </a:rPr>
                <a:t>Castrated NSG mouse </a:t>
              </a:r>
              <a:endParaRPr lang="en-IL" sz="1200" dirty="0">
                <a:ea typeface="Times New Roman" panose="02020603050405020304" pitchFamily="18" charset="0"/>
              </a:endParaRPr>
            </a:p>
          </p:txBody>
        </p:sp>
        <p:sp>
          <p:nvSpPr>
            <p:cNvPr id="7" name="TextBox 10">
              <a:extLst>
                <a:ext uri="{FF2B5EF4-FFF2-40B4-BE49-F238E27FC236}">
                  <a16:creationId xmlns:a16="http://schemas.microsoft.com/office/drawing/2014/main" id="{9DC56932-26A7-AA48-B3E0-AA6A2992110E}"/>
                </a:ext>
              </a:extLst>
            </p:cNvPr>
            <p:cNvSpPr txBox="1"/>
            <p:nvPr/>
          </p:nvSpPr>
          <p:spPr>
            <a:xfrm>
              <a:off x="597678" y="644374"/>
              <a:ext cx="2206336" cy="2062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ea typeface="Times New Roman" panose="02020603050405020304" pitchFamily="18" charset="0"/>
                  <a:cs typeface="Arial" panose="020B0604020202020204" pitchFamily="34" charset="0"/>
                </a:rPr>
                <a:t>Control NSG  mouse</a:t>
              </a:r>
              <a:endParaRPr lang="en-IL" sz="1200" dirty="0">
                <a:ea typeface="Times New Roman" panose="02020603050405020304" pitchFamily="18" charset="0"/>
              </a:endParaRPr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BFCE6A6C-BCB2-AE4A-929E-598FE4CA605E}"/>
                </a:ext>
              </a:extLst>
            </p:cNvPr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4857"/>
            <a:stretch/>
          </p:blipFill>
          <p:spPr>
            <a:xfrm>
              <a:off x="2289047" y="950393"/>
              <a:ext cx="1773572" cy="1276992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17DC683-EDAF-CD49-832E-98F1A2EDF147}"/>
                </a:ext>
              </a:extLst>
            </p:cNvPr>
            <p:cNvSpPr txBox="1"/>
            <p:nvPr/>
          </p:nvSpPr>
          <p:spPr>
            <a:xfrm>
              <a:off x="316524" y="468923"/>
              <a:ext cx="314197" cy="20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L" sz="1200" dirty="0"/>
                <a:t>a.</a:t>
              </a:r>
            </a:p>
          </p:txBody>
        </p: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552A10AF-8511-6040-B696-AF657E618A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9143"/>
            <a:stretch/>
          </p:blipFill>
          <p:spPr>
            <a:xfrm>
              <a:off x="409967" y="2931947"/>
              <a:ext cx="1750522" cy="1276992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AA918366-139A-3A4B-8D21-1DFA2B8A43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7643"/>
            <a:stretch/>
          </p:blipFill>
          <p:spPr>
            <a:xfrm>
              <a:off x="2474484" y="2931947"/>
              <a:ext cx="1787582" cy="1276993"/>
            </a:xfrm>
            <a:prstGeom prst="rect">
              <a:avLst/>
            </a:prstGeom>
          </p:spPr>
        </p:pic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99D2EBE0-65BC-BC45-B79A-47FA994AC46E}"/>
                </a:ext>
              </a:extLst>
            </p:cNvPr>
            <p:cNvSpPr/>
            <p:nvPr/>
          </p:nvSpPr>
          <p:spPr>
            <a:xfrm>
              <a:off x="2366156" y="2612629"/>
              <a:ext cx="3024570" cy="20623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>
                  <a:ea typeface="Calibri" panose="020F0502020204030204" pitchFamily="34" charset="0"/>
                </a:rPr>
                <a:t>NSG Rosiglitazone maleate treated mouse</a:t>
              </a:r>
              <a:endParaRPr lang="en-US" sz="120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C0354E3-2515-224D-812D-C96CFB95757C}"/>
                </a:ext>
              </a:extLst>
            </p:cNvPr>
            <p:cNvSpPr txBox="1"/>
            <p:nvPr/>
          </p:nvSpPr>
          <p:spPr>
            <a:xfrm>
              <a:off x="233477" y="2551140"/>
              <a:ext cx="320983" cy="20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L" sz="1200" dirty="0"/>
                <a:t>b.</a:t>
              </a:r>
            </a:p>
          </p:txBody>
        </p:sp>
        <p:pic>
          <p:nvPicPr>
            <p:cNvPr id="15" name="Picture 14" descr="1 year mice (Small)">
              <a:extLst>
                <a:ext uri="{FF2B5EF4-FFF2-40B4-BE49-F238E27FC236}">
                  <a16:creationId xmlns:a16="http://schemas.microsoft.com/office/drawing/2014/main" id="{DB0F7D2B-7960-B848-94B3-73CC113FD835}"/>
                </a:ext>
              </a:extLst>
            </p:cNvPr>
            <p:cNvPicPr/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9967" y="4542575"/>
              <a:ext cx="6848083" cy="184650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6" name="TextBox 10">
              <a:extLst>
                <a:ext uri="{FF2B5EF4-FFF2-40B4-BE49-F238E27FC236}">
                  <a16:creationId xmlns:a16="http://schemas.microsoft.com/office/drawing/2014/main" id="{8FAE9A3C-33B4-3F4F-9B32-438140F95021}"/>
                </a:ext>
              </a:extLst>
            </p:cNvPr>
            <p:cNvSpPr txBox="1"/>
            <p:nvPr/>
          </p:nvSpPr>
          <p:spPr>
            <a:xfrm>
              <a:off x="527550" y="4565353"/>
              <a:ext cx="2350812" cy="20623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ea typeface="Times New Roman" panose="02020603050405020304" pitchFamily="18" charset="0"/>
                  <a:cs typeface="Arial" panose="020B0604020202020204" pitchFamily="34" charset="0"/>
                </a:rPr>
                <a:t>NSG mouse  -1 year old</a:t>
              </a:r>
              <a:endParaRPr lang="en-IL" sz="1200" dirty="0">
                <a:ea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9C3D9B5-658C-0F4B-9380-858BB25CE4D5}"/>
                </a:ext>
              </a:extLst>
            </p:cNvPr>
            <p:cNvSpPr txBox="1"/>
            <p:nvPr/>
          </p:nvSpPr>
          <p:spPr>
            <a:xfrm>
              <a:off x="227866" y="4484723"/>
              <a:ext cx="305715" cy="20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L" sz="1200" dirty="0"/>
                <a:t>c.</a:t>
              </a:r>
            </a:p>
          </p:txBody>
        </p:sp>
        <p:sp>
          <p:nvSpPr>
            <p:cNvPr id="18" name="TextBox 10">
              <a:extLst>
                <a:ext uri="{FF2B5EF4-FFF2-40B4-BE49-F238E27FC236}">
                  <a16:creationId xmlns:a16="http://schemas.microsoft.com/office/drawing/2014/main" id="{A97BFEE2-16FB-4141-A451-C2B986B34676}"/>
                </a:ext>
              </a:extLst>
            </p:cNvPr>
            <p:cNvSpPr txBox="1"/>
            <p:nvPr/>
          </p:nvSpPr>
          <p:spPr>
            <a:xfrm>
              <a:off x="2366156" y="4438556"/>
              <a:ext cx="1879081" cy="34372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 err="1">
                  <a:solidFill>
                    <a:srgbClr val="000000"/>
                  </a:solidFill>
                  <a:ea typeface="Times New Roman" panose="02020603050405020304" pitchFamily="18" charset="0"/>
                  <a:cs typeface="Arial" panose="020B0604020202020204" pitchFamily="34" charset="0"/>
                </a:rPr>
                <a:t>hSCF</a:t>
              </a:r>
              <a:r>
                <a:rPr lang="en-US" sz="1200" dirty="0">
                  <a:solidFill>
                    <a:srgbClr val="000000"/>
                  </a:solidFill>
                  <a:ea typeface="Times New Roman" panose="02020603050405020304" pitchFamily="18" charset="0"/>
                  <a:cs typeface="Arial" panose="020B0604020202020204" pitchFamily="34" charset="0"/>
                </a:rPr>
                <a:t> mouse (</a:t>
              </a:r>
              <a:r>
                <a:rPr lang="en-US" sz="1200" dirty="0" err="1">
                  <a:solidFill>
                    <a:srgbClr val="000000"/>
                  </a:solidFill>
                  <a:ea typeface="Times New Roman" panose="02020603050405020304" pitchFamily="18" charset="0"/>
                  <a:cs typeface="Arial" panose="020B0604020202020204" pitchFamily="34" charset="0"/>
                </a:rPr>
                <a:t>hSCF</a:t>
              </a:r>
              <a:r>
                <a:rPr lang="en-US" sz="1200" dirty="0">
                  <a:solidFill>
                    <a:srgbClr val="000000"/>
                  </a:solidFill>
                  <a:ea typeface="Times New Roman" panose="02020603050405020304" pitchFamily="18" charset="0"/>
                  <a:cs typeface="Arial" panose="020B0604020202020204" pitchFamily="34" charset="0"/>
                </a:rPr>
                <a:t> cytokine) -1 year old</a:t>
              </a:r>
              <a:endParaRPr lang="en-IL" sz="1200" dirty="0">
                <a:ea typeface="Times New Roman" panose="02020603050405020304" pitchFamily="18" charset="0"/>
              </a:endParaRPr>
            </a:p>
          </p:txBody>
        </p:sp>
        <p:sp>
          <p:nvSpPr>
            <p:cNvPr id="19" name="TextBox 10">
              <a:extLst>
                <a:ext uri="{FF2B5EF4-FFF2-40B4-BE49-F238E27FC236}">
                  <a16:creationId xmlns:a16="http://schemas.microsoft.com/office/drawing/2014/main" id="{8753D5A0-AB95-0147-9E08-81347E2F0808}"/>
                </a:ext>
              </a:extLst>
            </p:cNvPr>
            <p:cNvSpPr txBox="1"/>
            <p:nvPr/>
          </p:nvSpPr>
          <p:spPr>
            <a:xfrm>
              <a:off x="4164289" y="4429324"/>
              <a:ext cx="2350812" cy="34372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ea typeface="Times New Roman" panose="02020603050405020304" pitchFamily="18" charset="0"/>
                  <a:cs typeface="Arial" panose="020B0604020202020204" pitchFamily="34" charset="0"/>
                </a:rPr>
                <a:t>NSG- SGM3 mouse (IL-3, </a:t>
              </a:r>
              <a:r>
                <a:rPr lang="en-US" sz="1200" dirty="0" err="1">
                  <a:solidFill>
                    <a:srgbClr val="000000"/>
                  </a:solidFill>
                  <a:ea typeface="Times New Roman" panose="02020603050405020304" pitchFamily="18" charset="0"/>
                  <a:cs typeface="Arial" panose="020B0604020202020204" pitchFamily="34" charset="0"/>
                </a:rPr>
                <a:t>hSCF</a:t>
              </a:r>
              <a:r>
                <a:rPr lang="en-US" sz="1200" dirty="0">
                  <a:solidFill>
                    <a:srgbClr val="000000"/>
                  </a:solidFill>
                  <a:ea typeface="Times New Roman" panose="02020603050405020304" pitchFamily="18" charset="0"/>
                  <a:cs typeface="Arial" panose="020B0604020202020204" pitchFamily="34" charset="0"/>
                </a:rPr>
                <a:t>, G-MSCF) -1 year old</a:t>
              </a:r>
              <a:endParaRPr lang="en-IL" sz="1200" dirty="0">
                <a:ea typeface="Times New Roman" panose="02020603050405020304" pitchFamily="18" charset="0"/>
              </a:endParaRP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6C587EBA-7429-5E46-8014-C57FA3A710B4}"/>
              </a:ext>
            </a:extLst>
          </p:cNvPr>
          <p:cNvSpPr txBox="1"/>
          <p:nvPr/>
        </p:nvSpPr>
        <p:spPr>
          <a:xfrm>
            <a:off x="4223642" y="80333"/>
            <a:ext cx="16161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xtended data</a:t>
            </a:r>
          </a:p>
          <a:p>
            <a:endParaRPr lang="en-US" sz="1200" dirty="0"/>
          </a:p>
        </p:txBody>
      </p:sp>
      <p:sp>
        <p:nvSpPr>
          <p:cNvPr id="21" name="TextBox 10">
            <a:extLst>
              <a:ext uri="{FF2B5EF4-FFF2-40B4-BE49-F238E27FC236}">
                <a16:creationId xmlns:a16="http://schemas.microsoft.com/office/drawing/2014/main" id="{32D87945-4289-9142-80A4-75BA0CDBDC3E}"/>
              </a:ext>
            </a:extLst>
          </p:cNvPr>
          <p:cNvSpPr txBox="1"/>
          <p:nvPr/>
        </p:nvSpPr>
        <p:spPr>
          <a:xfrm>
            <a:off x="713782" y="3457250"/>
            <a:ext cx="20847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0000"/>
                </a:solidFill>
                <a:ea typeface="Times New Roman" panose="02020603050405020304" pitchFamily="18" charset="0"/>
                <a:cs typeface="Arial" panose="020B0604020202020204" pitchFamily="34" charset="0"/>
              </a:rPr>
              <a:t>Control NSG  mouse</a:t>
            </a:r>
            <a:endParaRPr lang="en-IL" sz="1200" dirty="0">
              <a:ea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CD51360-1F56-4745-AE43-22DEC5750687}"/>
              </a:ext>
            </a:extLst>
          </p:cNvPr>
          <p:cNvSpPr txBox="1"/>
          <p:nvPr/>
        </p:nvSpPr>
        <p:spPr>
          <a:xfrm>
            <a:off x="2615157" y="9784080"/>
            <a:ext cx="10264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L" dirty="0"/>
              <a:t>Figure 1s</a:t>
            </a:r>
          </a:p>
        </p:txBody>
      </p:sp>
    </p:spTree>
    <p:extLst>
      <p:ext uri="{BB962C8B-B14F-4D97-AF65-F5344CB8AC3E}">
        <p14:creationId xmlns:p14="http://schemas.microsoft.com/office/powerpoint/2010/main" val="37938751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18E3B43-9AB8-3248-A78B-5A3C38D6276E}"/>
              </a:ext>
            </a:extLst>
          </p:cNvPr>
          <p:cNvSpPr txBox="1"/>
          <p:nvPr/>
        </p:nvSpPr>
        <p:spPr>
          <a:xfrm>
            <a:off x="280342" y="517742"/>
            <a:ext cx="932371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Castration</a:t>
            </a:r>
          </a:p>
          <a:p>
            <a:r>
              <a:rPr lang="en-US" sz="1400" dirty="0">
                <a:solidFill>
                  <a:srgbClr val="FF0000"/>
                </a:solidFill>
              </a:rPr>
              <a:t>NSG mice</a:t>
            </a:r>
          </a:p>
          <a:p>
            <a:r>
              <a:rPr lang="en-US" sz="1400" dirty="0">
                <a:solidFill>
                  <a:srgbClr val="FF0000"/>
                </a:solidFill>
              </a:rPr>
              <a:t> </a:t>
            </a: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86DA95E9-A165-F247-B428-7DD2AD3CFE58}"/>
              </a:ext>
            </a:extLst>
          </p:cNvPr>
          <p:cNvCxnSpPr/>
          <p:nvPr/>
        </p:nvCxnSpPr>
        <p:spPr>
          <a:xfrm>
            <a:off x="1832854" y="1332517"/>
            <a:ext cx="82193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C6E56561-031B-5743-8784-174874442DD5}"/>
              </a:ext>
            </a:extLst>
          </p:cNvPr>
          <p:cNvSpPr txBox="1"/>
          <p:nvPr/>
        </p:nvSpPr>
        <p:spPr>
          <a:xfrm>
            <a:off x="1747988" y="837026"/>
            <a:ext cx="13491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ollowing 1 month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B4A4D99-6090-2B4F-B395-D38BA02F5F40}"/>
              </a:ext>
            </a:extLst>
          </p:cNvPr>
          <p:cNvSpPr txBox="1"/>
          <p:nvPr/>
        </p:nvSpPr>
        <p:spPr>
          <a:xfrm>
            <a:off x="1759163" y="1036638"/>
            <a:ext cx="17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Human BM was injecte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EDC0DF8-4424-8F4D-9186-CE1B4491D001}"/>
              </a:ext>
            </a:extLst>
          </p:cNvPr>
          <p:cNvSpPr txBox="1"/>
          <p:nvPr/>
        </p:nvSpPr>
        <p:spPr>
          <a:xfrm>
            <a:off x="239486" y="1755527"/>
            <a:ext cx="12923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accent1"/>
                </a:solidFill>
              </a:rPr>
              <a:t>NBM NSG mice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4E758466-EDCB-1C42-9BFE-104B5B9FCE22}"/>
              </a:ext>
            </a:extLst>
          </p:cNvPr>
          <p:cNvCxnSpPr/>
          <p:nvPr/>
        </p:nvCxnSpPr>
        <p:spPr>
          <a:xfrm>
            <a:off x="1759163" y="2344056"/>
            <a:ext cx="82193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Picture 9">
            <a:extLst>
              <a:ext uri="{FF2B5EF4-FFF2-40B4-BE49-F238E27FC236}">
                <a16:creationId xmlns:a16="http://schemas.microsoft.com/office/drawing/2014/main" id="{CF56C04A-15CC-FF48-B26B-96B93BCCB5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6355" y="946913"/>
            <a:ext cx="561428" cy="66836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97D6BFA3-2F29-794D-9B3F-C2D203B659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2347" y="2019002"/>
            <a:ext cx="561428" cy="668366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D936828-E130-7A4E-89C4-D562B0595C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78378" y="946913"/>
            <a:ext cx="561428" cy="66836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22190B04-F455-2749-A5BE-20F72D8D93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73025" y="1901911"/>
            <a:ext cx="561428" cy="668366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BB5F614A-4060-E346-A7E5-8A1AD0ECD2DF}"/>
              </a:ext>
            </a:extLst>
          </p:cNvPr>
          <p:cNvSpPr txBox="1"/>
          <p:nvPr/>
        </p:nvSpPr>
        <p:spPr>
          <a:xfrm>
            <a:off x="1673165" y="1916920"/>
            <a:ext cx="13491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ollowing 1 month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46BCBE6-E950-A24D-B511-492A83267FD7}"/>
              </a:ext>
            </a:extLst>
          </p:cNvPr>
          <p:cNvSpPr txBox="1"/>
          <p:nvPr/>
        </p:nvSpPr>
        <p:spPr>
          <a:xfrm>
            <a:off x="1664955" y="2084871"/>
            <a:ext cx="12152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M was injected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5D0A4DC5-0014-5F49-A475-7F66A02B3424}"/>
              </a:ext>
            </a:extLst>
          </p:cNvPr>
          <p:cNvCxnSpPr>
            <a:cxnSpLocks/>
          </p:cNvCxnSpPr>
          <p:nvPr/>
        </p:nvCxnSpPr>
        <p:spPr>
          <a:xfrm>
            <a:off x="3746879" y="1476441"/>
            <a:ext cx="1300827" cy="8234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7365DDCD-E570-FE45-9148-7804ACBC5F16}"/>
              </a:ext>
            </a:extLst>
          </p:cNvPr>
          <p:cNvSpPr txBox="1"/>
          <p:nvPr/>
        </p:nvSpPr>
        <p:spPr>
          <a:xfrm>
            <a:off x="4888987" y="2344056"/>
            <a:ext cx="17107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Engraftment analysis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5D0A4DC5-0014-5F49-A475-7F66A02B3424}"/>
              </a:ext>
            </a:extLst>
          </p:cNvPr>
          <p:cNvCxnSpPr>
            <a:cxnSpLocks/>
            <a:endCxn id="23" idx="1"/>
          </p:cNvCxnSpPr>
          <p:nvPr/>
        </p:nvCxnSpPr>
        <p:spPr>
          <a:xfrm>
            <a:off x="3638320" y="2361870"/>
            <a:ext cx="1250667" cy="13607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B17DC683-EDAF-CD49-832E-98F1A2EDF147}"/>
              </a:ext>
            </a:extLst>
          </p:cNvPr>
          <p:cNvSpPr txBox="1"/>
          <p:nvPr/>
        </p:nvSpPr>
        <p:spPr>
          <a:xfrm>
            <a:off x="525817" y="-3176128"/>
            <a:ext cx="296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L" sz="1200" dirty="0"/>
              <a:t>a.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706DB0D-1091-E54B-BB88-1CFE0C47166E}"/>
              </a:ext>
            </a:extLst>
          </p:cNvPr>
          <p:cNvSpPr txBox="1"/>
          <p:nvPr/>
        </p:nvSpPr>
        <p:spPr>
          <a:xfrm>
            <a:off x="1726088" y="3097931"/>
            <a:ext cx="180836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ollowing 1 week</a:t>
            </a:r>
          </a:p>
          <a:p>
            <a:r>
              <a:rPr lang="en-US" sz="1200" dirty="0"/>
              <a:t>Human AML/ DNMT3A</a:t>
            </a:r>
            <a:r>
              <a:rPr lang="en-US" sz="1200" baseline="30000" dirty="0"/>
              <a:t>+</a:t>
            </a:r>
            <a:r>
              <a:rPr lang="en-US" sz="1200" dirty="0"/>
              <a:t>VAV</a:t>
            </a:r>
            <a:r>
              <a:rPr lang="en-US" sz="1200" baseline="30000" dirty="0"/>
              <a:t>+</a:t>
            </a:r>
            <a:r>
              <a:rPr lang="en-US" sz="1200" dirty="0"/>
              <a:t> derived BM Was injected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EBC843CB-FEEF-FF47-8A24-88E8B704FD08}"/>
              </a:ext>
            </a:extLst>
          </p:cNvPr>
          <p:cNvCxnSpPr/>
          <p:nvPr/>
        </p:nvCxnSpPr>
        <p:spPr>
          <a:xfrm>
            <a:off x="3091686" y="3421097"/>
            <a:ext cx="82193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2" name="Picture 31">
            <a:extLst>
              <a:ext uri="{FF2B5EF4-FFF2-40B4-BE49-F238E27FC236}">
                <a16:creationId xmlns:a16="http://schemas.microsoft.com/office/drawing/2014/main" id="{95B1A8EA-6AEE-0F46-A498-A7B534FD5E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9074" y="3232688"/>
            <a:ext cx="561428" cy="668366"/>
          </a:xfrm>
          <a:prstGeom prst="rect">
            <a:avLst/>
          </a:prstGeom>
        </p:spPr>
      </p:pic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3AE55E78-1EB9-564A-829C-B54E74026146}"/>
              </a:ext>
            </a:extLst>
          </p:cNvPr>
          <p:cNvCxnSpPr/>
          <p:nvPr/>
        </p:nvCxnSpPr>
        <p:spPr>
          <a:xfrm>
            <a:off x="3022317" y="4585653"/>
            <a:ext cx="82193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5" name="Picture 34">
            <a:extLst>
              <a:ext uri="{FF2B5EF4-FFF2-40B4-BE49-F238E27FC236}">
                <a16:creationId xmlns:a16="http://schemas.microsoft.com/office/drawing/2014/main" id="{CE8F1FA7-F630-1D47-ABF1-A2D12F4C5A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9074" y="4251470"/>
            <a:ext cx="561428" cy="668366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D706DB0D-1091-E54B-BB88-1CFE0C47166E}"/>
              </a:ext>
            </a:extLst>
          </p:cNvPr>
          <p:cNvSpPr txBox="1"/>
          <p:nvPr/>
        </p:nvSpPr>
        <p:spPr>
          <a:xfrm>
            <a:off x="1650727" y="4249490"/>
            <a:ext cx="180836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ollowing 1 week</a:t>
            </a:r>
          </a:p>
          <a:p>
            <a:r>
              <a:rPr lang="en-US" sz="1200" dirty="0"/>
              <a:t>Human AML/ DNMT3A</a:t>
            </a:r>
            <a:r>
              <a:rPr lang="en-US" sz="1200" baseline="30000" dirty="0"/>
              <a:t>+</a:t>
            </a:r>
            <a:r>
              <a:rPr lang="en-US" sz="1200" dirty="0"/>
              <a:t>VAV</a:t>
            </a:r>
            <a:r>
              <a:rPr lang="en-US" sz="1200" baseline="30000" dirty="0"/>
              <a:t>+</a:t>
            </a:r>
            <a:r>
              <a:rPr lang="en-US" sz="1200" dirty="0"/>
              <a:t> derived BM Was injected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CF56C04A-15CC-FF48-B26B-96B93BCCB5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8686" y="3179381"/>
            <a:ext cx="561428" cy="668366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97D6BFA3-2F29-794D-9B3F-C2D203B659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4678" y="4251470"/>
            <a:ext cx="561428" cy="668366"/>
          </a:xfrm>
          <a:prstGeom prst="rect">
            <a:avLst/>
          </a:prstGeom>
        </p:spPr>
      </p:pic>
      <p:sp>
        <p:nvSpPr>
          <p:cNvPr id="39" name="Rectangle 38"/>
          <p:cNvSpPr/>
          <p:nvPr/>
        </p:nvSpPr>
        <p:spPr>
          <a:xfrm>
            <a:off x="209319" y="3135358"/>
            <a:ext cx="3429000" cy="738664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Low dose</a:t>
            </a:r>
          </a:p>
          <a:p>
            <a:r>
              <a:rPr lang="en-US" sz="1400" dirty="0">
                <a:solidFill>
                  <a:srgbClr val="FF0000"/>
                </a:solidFill>
              </a:rPr>
              <a:t>irradiation</a:t>
            </a:r>
          </a:p>
          <a:p>
            <a:r>
              <a:rPr lang="en-US" sz="1400" dirty="0">
                <a:solidFill>
                  <a:srgbClr val="FF0000"/>
                </a:solidFill>
              </a:rPr>
              <a:t>NSG mice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EDC0DF8-4424-8F4D-9186-CE1B4491D001}"/>
              </a:ext>
            </a:extLst>
          </p:cNvPr>
          <p:cNvSpPr txBox="1"/>
          <p:nvPr/>
        </p:nvSpPr>
        <p:spPr>
          <a:xfrm>
            <a:off x="276075" y="4511099"/>
            <a:ext cx="88517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accent1"/>
                </a:solidFill>
              </a:rPr>
              <a:t>NBM </a:t>
            </a:r>
          </a:p>
          <a:p>
            <a:r>
              <a:rPr lang="en-US" sz="1400" dirty="0">
                <a:solidFill>
                  <a:schemeClr val="accent1"/>
                </a:solidFill>
              </a:rPr>
              <a:t>NSG mice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18E3B43-9AB8-3248-A78B-5A3C38D6276E}"/>
              </a:ext>
            </a:extLst>
          </p:cNvPr>
          <p:cNvSpPr txBox="1"/>
          <p:nvPr/>
        </p:nvSpPr>
        <p:spPr>
          <a:xfrm>
            <a:off x="3183291" y="432789"/>
            <a:ext cx="910057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Castrated</a:t>
            </a:r>
          </a:p>
          <a:p>
            <a:r>
              <a:rPr lang="en-US" sz="1400" dirty="0">
                <a:solidFill>
                  <a:srgbClr val="FF0000"/>
                </a:solidFill>
              </a:rPr>
              <a:t>NSG mice</a:t>
            </a:r>
          </a:p>
          <a:p>
            <a:r>
              <a:rPr lang="en-US" sz="1400" dirty="0">
                <a:solidFill>
                  <a:srgbClr val="FF0000"/>
                </a:solidFill>
              </a:rPr>
              <a:t> 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EDC0DF8-4424-8F4D-9186-CE1B4491D001}"/>
              </a:ext>
            </a:extLst>
          </p:cNvPr>
          <p:cNvSpPr txBox="1"/>
          <p:nvPr/>
        </p:nvSpPr>
        <p:spPr>
          <a:xfrm>
            <a:off x="3093635" y="1642860"/>
            <a:ext cx="12923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accent1"/>
                </a:solidFill>
              </a:rPr>
              <a:t>NBM NSG mice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5D0A4DC5-0014-5F49-A475-7F66A02B3424}"/>
              </a:ext>
            </a:extLst>
          </p:cNvPr>
          <p:cNvCxnSpPr>
            <a:cxnSpLocks/>
          </p:cNvCxnSpPr>
          <p:nvPr/>
        </p:nvCxnSpPr>
        <p:spPr>
          <a:xfrm flipV="1">
            <a:off x="4417779" y="2764922"/>
            <a:ext cx="471208" cy="7397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5D0A4DC5-0014-5F49-A475-7F66A02B3424}"/>
              </a:ext>
            </a:extLst>
          </p:cNvPr>
          <p:cNvCxnSpPr>
            <a:cxnSpLocks/>
          </p:cNvCxnSpPr>
          <p:nvPr/>
        </p:nvCxnSpPr>
        <p:spPr>
          <a:xfrm flipV="1">
            <a:off x="4349217" y="3004823"/>
            <a:ext cx="698489" cy="155749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01F2B881-60E3-B245-8E71-4C2EDD1905B1}"/>
              </a:ext>
            </a:extLst>
          </p:cNvPr>
          <p:cNvSpPr txBox="1"/>
          <p:nvPr/>
        </p:nvSpPr>
        <p:spPr>
          <a:xfrm>
            <a:off x="3208858" y="9645464"/>
            <a:ext cx="10264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L" dirty="0"/>
              <a:t>Figure 2s</a:t>
            </a:r>
          </a:p>
        </p:txBody>
      </p:sp>
    </p:spTree>
    <p:extLst>
      <p:ext uri="{BB962C8B-B14F-4D97-AF65-F5344CB8AC3E}">
        <p14:creationId xmlns:p14="http://schemas.microsoft.com/office/powerpoint/2010/main" val="221011122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9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9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10" dur="5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9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13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9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16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" presetID="9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19" dur="500"/>
                                        <p:tgtEl>
                                          <p:spTgt spid="3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0" presetID="9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22" dur="500"/>
                                        <p:tgtEl>
                                          <p:spTgt spid="3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3" presetID="9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25" dur="500"/>
                                        <p:tgtEl>
                                          <p:spTgt spid="3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6" presetID="9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28" dur="500"/>
                                        <p:tgtEl>
                                          <p:spTgt spid="3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FD73D1A-6B0D-8047-8F9F-6A34B1A7C66A}"/>
              </a:ext>
            </a:extLst>
          </p:cNvPr>
          <p:cNvSpPr txBox="1"/>
          <p:nvPr/>
        </p:nvSpPr>
        <p:spPr>
          <a:xfrm>
            <a:off x="502687" y="351254"/>
            <a:ext cx="588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76ED6B7-A416-4143-B36D-48A9DCF21F7B}"/>
              </a:ext>
            </a:extLst>
          </p:cNvPr>
          <p:cNvSpPr txBox="1"/>
          <p:nvPr/>
        </p:nvSpPr>
        <p:spPr>
          <a:xfrm>
            <a:off x="2890135" y="363751"/>
            <a:ext cx="5998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E614A52-B724-8948-A653-C0FAB7926F1B}"/>
              </a:ext>
            </a:extLst>
          </p:cNvPr>
          <p:cNvSpPr txBox="1"/>
          <p:nvPr/>
        </p:nvSpPr>
        <p:spPr>
          <a:xfrm>
            <a:off x="502687" y="5882415"/>
            <a:ext cx="5659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505F837-B08A-BB42-AA96-5A850B34DB00}"/>
              </a:ext>
            </a:extLst>
          </p:cNvPr>
          <p:cNvSpPr txBox="1"/>
          <p:nvPr/>
        </p:nvSpPr>
        <p:spPr>
          <a:xfrm>
            <a:off x="367199" y="3254663"/>
            <a:ext cx="5778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B9376BA-4815-C04B-B5CB-9A75BA499A3C}"/>
              </a:ext>
            </a:extLst>
          </p:cNvPr>
          <p:cNvSpPr txBox="1"/>
          <p:nvPr/>
        </p:nvSpPr>
        <p:spPr>
          <a:xfrm>
            <a:off x="3268374" y="3316784"/>
            <a:ext cx="1151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rimary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C3133B9-02A1-4446-A55C-4F0A8E51C338}"/>
              </a:ext>
            </a:extLst>
          </p:cNvPr>
          <p:cNvSpPr txBox="1"/>
          <p:nvPr/>
        </p:nvSpPr>
        <p:spPr>
          <a:xfrm>
            <a:off x="5225607" y="3307094"/>
            <a:ext cx="13815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econdary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CFA9F90-0F88-204E-A857-006E1DF5F376}"/>
              </a:ext>
            </a:extLst>
          </p:cNvPr>
          <p:cNvSpPr txBox="1"/>
          <p:nvPr/>
        </p:nvSpPr>
        <p:spPr>
          <a:xfrm>
            <a:off x="2488509" y="3226721"/>
            <a:ext cx="5998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B7A4636-D201-6D42-92A8-CF2367DBFB56}"/>
              </a:ext>
            </a:extLst>
          </p:cNvPr>
          <p:cNvSpPr txBox="1"/>
          <p:nvPr/>
        </p:nvSpPr>
        <p:spPr>
          <a:xfrm>
            <a:off x="1337109" y="173027"/>
            <a:ext cx="1151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rimary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982FC0E-35F6-A04D-B23C-8A16BE91BEF7}"/>
              </a:ext>
            </a:extLst>
          </p:cNvPr>
          <p:cNvSpPr txBox="1"/>
          <p:nvPr/>
        </p:nvSpPr>
        <p:spPr>
          <a:xfrm>
            <a:off x="3448665" y="173027"/>
            <a:ext cx="13815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econdary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125CAF5-43E9-7342-B331-70E0A07CA06C}"/>
              </a:ext>
            </a:extLst>
          </p:cNvPr>
          <p:cNvSpPr txBox="1"/>
          <p:nvPr/>
        </p:nvSpPr>
        <p:spPr>
          <a:xfrm>
            <a:off x="4627498" y="3206871"/>
            <a:ext cx="5659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.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C43DA5C-2BB8-E44F-BDB8-F9827E393A86}"/>
              </a:ext>
            </a:extLst>
          </p:cNvPr>
          <p:cNvSpPr txBox="1"/>
          <p:nvPr/>
        </p:nvSpPr>
        <p:spPr>
          <a:xfrm>
            <a:off x="2221761" y="-33353"/>
            <a:ext cx="1305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L" sz="1200" dirty="0"/>
              <a:t>2 month old mic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C8B8A1F-EF7E-EC41-8146-A0DACE9CE7B3}"/>
              </a:ext>
            </a:extLst>
          </p:cNvPr>
          <p:cNvSpPr txBox="1"/>
          <p:nvPr/>
        </p:nvSpPr>
        <p:spPr>
          <a:xfrm>
            <a:off x="2191303" y="2806756"/>
            <a:ext cx="1341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</a:t>
            </a:r>
            <a:r>
              <a:rPr lang="en-IL" sz="1200" dirty="0"/>
              <a:t>ne year old mice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B77D432-DFB6-2D40-8017-E1B57C56C1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8301" y="477576"/>
            <a:ext cx="2113267" cy="199056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DA0F4BA-3F2D-6941-B0D4-F35A4958663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70781" y="3552863"/>
            <a:ext cx="2426498" cy="2033976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5F994073-6EBD-7A4E-91CF-DA42B1A2403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7392" y="3103199"/>
            <a:ext cx="1946486" cy="2346346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B864A559-EE70-6D42-AFC3-9E4E86E4A5C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65486" y="3510607"/>
            <a:ext cx="2328146" cy="2033976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7545C2F0-57EB-714E-8802-6E8079041B7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30452" y="590125"/>
            <a:ext cx="2598955" cy="1878012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518562EB-175B-204A-BCA7-8C34A61D82B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4333" y="5824947"/>
            <a:ext cx="3105324" cy="2928143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FD86BB93-6B19-5944-965C-F49DD0C9FE96}"/>
              </a:ext>
            </a:extLst>
          </p:cNvPr>
          <p:cNvSpPr txBox="1"/>
          <p:nvPr/>
        </p:nvSpPr>
        <p:spPr>
          <a:xfrm>
            <a:off x="3208858" y="9645464"/>
            <a:ext cx="10264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L" dirty="0"/>
              <a:t>Figure 3s</a:t>
            </a:r>
          </a:p>
        </p:txBody>
      </p:sp>
    </p:spTree>
    <p:extLst>
      <p:ext uri="{BB962C8B-B14F-4D97-AF65-F5344CB8AC3E}">
        <p14:creationId xmlns:p14="http://schemas.microsoft.com/office/powerpoint/2010/main" val="29437716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4B34CEFB-BF48-084F-A782-16A4A312C0D6}"/>
              </a:ext>
            </a:extLst>
          </p:cNvPr>
          <p:cNvSpPr txBox="1"/>
          <p:nvPr/>
        </p:nvSpPr>
        <p:spPr>
          <a:xfrm>
            <a:off x="5139297" y="4494252"/>
            <a:ext cx="1890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econdary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B049F14-69E1-F042-9653-45AC0FC13984}"/>
              </a:ext>
            </a:extLst>
          </p:cNvPr>
          <p:cNvSpPr txBox="1"/>
          <p:nvPr/>
        </p:nvSpPr>
        <p:spPr>
          <a:xfrm>
            <a:off x="275273" y="563931"/>
            <a:ext cx="679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200" dirty="0"/>
              <a:t>a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158D7BC-E185-854F-8654-9838110C4BFA}"/>
              </a:ext>
            </a:extLst>
          </p:cNvPr>
          <p:cNvSpPr txBox="1"/>
          <p:nvPr/>
        </p:nvSpPr>
        <p:spPr>
          <a:xfrm>
            <a:off x="426168" y="4469577"/>
            <a:ext cx="6946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200" dirty="0"/>
              <a:t>b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0560A9D-0077-6C47-B106-0BA01987FB89}"/>
              </a:ext>
            </a:extLst>
          </p:cNvPr>
          <p:cNvSpPr txBox="1"/>
          <p:nvPr/>
        </p:nvSpPr>
        <p:spPr>
          <a:xfrm>
            <a:off x="1539872" y="4494252"/>
            <a:ext cx="15408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rimary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2C6E90C-5BA5-A045-95EE-0BC387D357B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5592" y="840930"/>
            <a:ext cx="4632381" cy="313322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284E27A-BFDF-E741-8AB8-516044A9C3B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597" y="4719203"/>
            <a:ext cx="4040729" cy="271103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13164CC-08FC-CE49-9888-A78E23066E0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92524" y="4629566"/>
            <a:ext cx="3165033" cy="271103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93114D6-5864-834A-BF26-FF46C588D3AD}"/>
              </a:ext>
            </a:extLst>
          </p:cNvPr>
          <p:cNvSpPr txBox="1"/>
          <p:nvPr/>
        </p:nvSpPr>
        <p:spPr>
          <a:xfrm>
            <a:off x="1184308" y="583857"/>
            <a:ext cx="1305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L" sz="1200" dirty="0"/>
              <a:t>2 month old mic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FAB2E24-2910-9241-B6C2-6A934E61F96D}"/>
              </a:ext>
            </a:extLst>
          </p:cNvPr>
          <p:cNvSpPr txBox="1"/>
          <p:nvPr/>
        </p:nvSpPr>
        <p:spPr>
          <a:xfrm>
            <a:off x="773497" y="4231904"/>
            <a:ext cx="11559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L" sz="1200" dirty="0"/>
              <a:t>1 year old mic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F625D17-2300-BE49-B2D6-8CC206C504A3}"/>
              </a:ext>
            </a:extLst>
          </p:cNvPr>
          <p:cNvSpPr txBox="1"/>
          <p:nvPr/>
        </p:nvSpPr>
        <p:spPr>
          <a:xfrm>
            <a:off x="3208858" y="9645464"/>
            <a:ext cx="10264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L" dirty="0"/>
              <a:t>Figure 4s</a:t>
            </a:r>
          </a:p>
        </p:txBody>
      </p:sp>
    </p:spTree>
    <p:extLst>
      <p:ext uri="{BB962C8B-B14F-4D97-AF65-F5344CB8AC3E}">
        <p14:creationId xmlns:p14="http://schemas.microsoft.com/office/powerpoint/2010/main" val="16854639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8850" y="146891"/>
            <a:ext cx="2107289" cy="138637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505" y="146891"/>
            <a:ext cx="2137345" cy="1406148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330" y="1730506"/>
            <a:ext cx="2315667" cy="1523465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1159" y="1828414"/>
            <a:ext cx="2074980" cy="1365119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8789" y="1767977"/>
            <a:ext cx="2166845" cy="1425556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6904" y="5333493"/>
            <a:ext cx="2214196" cy="1456708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673" y="5278541"/>
            <a:ext cx="2381250" cy="1566612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-54930" y="-72410"/>
            <a:ext cx="296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.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-45509" y="1556953"/>
            <a:ext cx="303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.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-33765" y="3276288"/>
            <a:ext cx="296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.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-54930" y="5087736"/>
            <a:ext cx="303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.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559776" y="5087736"/>
            <a:ext cx="303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e.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-52188" y="6938034"/>
            <a:ext cx="2594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.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7" y="7374361"/>
            <a:ext cx="6858000" cy="3581201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297" t="8390" r="-260" b="18982"/>
          <a:stretch/>
        </p:blipFill>
        <p:spPr>
          <a:xfrm>
            <a:off x="6041070" y="4189241"/>
            <a:ext cx="751840" cy="260096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330" y="3508890"/>
            <a:ext cx="1789198" cy="1603293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08FA5CEC-8368-574A-BA66-1F0C59E55819}"/>
              </a:ext>
            </a:extLst>
          </p:cNvPr>
          <p:cNvSpPr txBox="1"/>
          <p:nvPr/>
        </p:nvSpPr>
        <p:spPr>
          <a:xfrm>
            <a:off x="3147898" y="11300104"/>
            <a:ext cx="10264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L" dirty="0"/>
              <a:t>Figure 5s</a:t>
            </a:r>
          </a:p>
        </p:txBody>
      </p:sp>
    </p:spTree>
    <p:extLst>
      <p:ext uri="{BB962C8B-B14F-4D97-AF65-F5344CB8AC3E}">
        <p14:creationId xmlns:p14="http://schemas.microsoft.com/office/powerpoint/2010/main" val="20280522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6862"/>
            <a:ext cx="296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.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-8177" y="2915806"/>
            <a:ext cx="303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.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021" y="3263965"/>
            <a:ext cx="2402480" cy="2402480"/>
          </a:xfrm>
          <a:prstGeom prst="rect">
            <a:avLst/>
          </a:prstGeom>
        </p:spPr>
      </p:pic>
      <p:grpSp>
        <p:nvGrpSpPr>
          <p:cNvPr id="13" name="Group 12"/>
          <p:cNvGrpSpPr/>
          <p:nvPr/>
        </p:nvGrpSpPr>
        <p:grpSpPr>
          <a:xfrm>
            <a:off x="288862" y="293861"/>
            <a:ext cx="3931170" cy="2478420"/>
            <a:chOff x="342692" y="357189"/>
            <a:chExt cx="3931170" cy="2478420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968" r="16030"/>
            <a:stretch/>
          </p:blipFill>
          <p:spPr>
            <a:xfrm>
              <a:off x="342692" y="357189"/>
              <a:ext cx="3467308" cy="2478420"/>
            </a:xfrm>
            <a:prstGeom prst="rect">
              <a:avLst/>
            </a:prstGeom>
          </p:spPr>
        </p:pic>
        <p:grpSp>
          <p:nvGrpSpPr>
            <p:cNvPr id="18" name="Group 17"/>
            <p:cNvGrpSpPr/>
            <p:nvPr/>
          </p:nvGrpSpPr>
          <p:grpSpPr>
            <a:xfrm>
              <a:off x="2402755" y="1722420"/>
              <a:ext cx="1871107" cy="945063"/>
              <a:chOff x="5551789" y="4103504"/>
              <a:chExt cx="2521726" cy="1304417"/>
            </a:xfrm>
          </p:grpSpPr>
          <p:pic>
            <p:nvPicPr>
              <p:cNvPr id="21" name="Picture 20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7787" t="44553" r="8953" b="42927"/>
              <a:stretch/>
            </p:blipFill>
            <p:spPr>
              <a:xfrm>
                <a:off x="5551789" y="4103504"/>
                <a:ext cx="520765" cy="1304417"/>
              </a:xfrm>
              <a:prstGeom prst="rect">
                <a:avLst/>
              </a:prstGeom>
            </p:spPr>
          </p:pic>
          <p:sp>
            <p:nvSpPr>
              <p:cNvPr id="22" name="TextBox 21"/>
              <p:cNvSpPr txBox="1"/>
              <p:nvPr/>
            </p:nvSpPr>
            <p:spPr>
              <a:xfrm>
                <a:off x="6072554" y="4103504"/>
                <a:ext cx="1195046" cy="3823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Unselected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6072554" y="4444010"/>
                <a:ext cx="2000961" cy="3823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DNMT3A </a:t>
                </a:r>
                <a:r>
                  <a:rPr lang="en-US" sz="1200" dirty="0" err="1"/>
                  <a:t>Mut</a:t>
                </a:r>
                <a:r>
                  <a:rPr lang="en-US" sz="1200" dirty="0"/>
                  <a:t> + FBM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6096001" y="4813342"/>
                <a:ext cx="1931829" cy="3823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DNMT3A WT + FBM</a:t>
                </a:r>
              </a:p>
            </p:txBody>
          </p:sp>
        </p:grpSp>
      </p:grpSp>
      <p:pic>
        <p:nvPicPr>
          <p:cNvPr id="25" name="Picture 2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021" y="5953249"/>
            <a:ext cx="2446011" cy="2446011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4276" y="3205526"/>
            <a:ext cx="2460919" cy="246091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4275" y="5953249"/>
            <a:ext cx="2446011" cy="2446011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2911406D-31F3-C241-ACE7-168D8670CBDA}"/>
              </a:ext>
            </a:extLst>
          </p:cNvPr>
          <p:cNvSpPr txBox="1"/>
          <p:nvPr/>
        </p:nvSpPr>
        <p:spPr>
          <a:xfrm>
            <a:off x="3208858" y="9645464"/>
            <a:ext cx="10264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L" dirty="0"/>
              <a:t>Figure 6s</a:t>
            </a:r>
          </a:p>
        </p:txBody>
      </p:sp>
    </p:spTree>
    <p:extLst>
      <p:ext uri="{BB962C8B-B14F-4D97-AF65-F5344CB8AC3E}">
        <p14:creationId xmlns:p14="http://schemas.microsoft.com/office/powerpoint/2010/main" val="8890077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17215" y="0"/>
            <a:ext cx="296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.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17215" y="2610336"/>
            <a:ext cx="303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.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17215" y="5787434"/>
            <a:ext cx="2888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.</a:t>
            </a:r>
          </a:p>
        </p:txBody>
      </p:sp>
      <p:grpSp>
        <p:nvGrpSpPr>
          <p:cNvPr id="22" name="Group 21"/>
          <p:cNvGrpSpPr/>
          <p:nvPr/>
        </p:nvGrpSpPr>
        <p:grpSpPr>
          <a:xfrm>
            <a:off x="686026" y="86155"/>
            <a:ext cx="4316775" cy="2741625"/>
            <a:chOff x="568039" y="321733"/>
            <a:chExt cx="4569100" cy="3791690"/>
          </a:xfrm>
        </p:grpSpPr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33" t="8894" r="25330" b="10786"/>
            <a:stretch/>
          </p:blipFill>
          <p:spPr>
            <a:xfrm>
              <a:off x="877528" y="410059"/>
              <a:ext cx="4259611" cy="3703364"/>
            </a:xfrm>
            <a:prstGeom prst="rect">
              <a:avLst/>
            </a:prstGeom>
          </p:spPr>
        </p:pic>
        <p:sp>
          <p:nvSpPr>
            <p:cNvPr id="24" name="TextBox 23"/>
            <p:cNvSpPr txBox="1"/>
            <p:nvPr/>
          </p:nvSpPr>
          <p:spPr>
            <a:xfrm>
              <a:off x="568039" y="1216575"/>
              <a:ext cx="390920" cy="106990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1200" b="1" dirty="0"/>
                <a:t>INFA Score</a:t>
              </a: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1305232" y="321733"/>
              <a:ext cx="683549" cy="38309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</a:rPr>
                <a:t>***</a:t>
              </a:r>
              <a:endParaRPr lang="en-US" sz="1200" dirty="0"/>
            </a:p>
          </p:txBody>
        </p:sp>
        <p:cxnSp>
          <p:nvCxnSpPr>
            <p:cNvPr id="26" name="Straight Connector 25"/>
            <p:cNvCxnSpPr/>
            <p:nvPr/>
          </p:nvCxnSpPr>
          <p:spPr>
            <a:xfrm>
              <a:off x="1364226" y="582561"/>
              <a:ext cx="427703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1774930" y="695981"/>
              <a:ext cx="427703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Rectangle 27"/>
            <p:cNvSpPr/>
            <p:nvPr/>
          </p:nvSpPr>
          <p:spPr>
            <a:xfrm>
              <a:off x="1732936" y="429915"/>
              <a:ext cx="683549" cy="38309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</a:rPr>
                <a:t>****</a:t>
              </a:r>
              <a:endParaRPr lang="en-US" sz="1200" dirty="0"/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481417" y="2809588"/>
            <a:ext cx="4594326" cy="2939469"/>
            <a:chOff x="4224364" y="1995203"/>
            <a:chExt cx="4667852" cy="3946886"/>
          </a:xfrm>
        </p:grpSpPr>
        <p:pic>
          <p:nvPicPr>
            <p:cNvPr id="30" name="Picture 29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28" t="5704" r="25473" b="10720"/>
            <a:stretch/>
          </p:blipFill>
          <p:spPr>
            <a:xfrm>
              <a:off x="4692255" y="2088653"/>
              <a:ext cx="4199961" cy="3853436"/>
            </a:xfrm>
            <a:prstGeom prst="rect">
              <a:avLst/>
            </a:prstGeom>
          </p:spPr>
        </p:pic>
        <p:sp>
          <p:nvSpPr>
            <p:cNvPr id="31" name="TextBox 30"/>
            <p:cNvSpPr txBox="1"/>
            <p:nvPr/>
          </p:nvSpPr>
          <p:spPr>
            <a:xfrm>
              <a:off x="4224364" y="1995203"/>
              <a:ext cx="375243" cy="2359101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1200" b="1" dirty="0"/>
                <a:t>INFA Score wo INFG genes</a:t>
              </a:r>
            </a:p>
          </p:txBody>
        </p:sp>
        <p:cxnSp>
          <p:nvCxnSpPr>
            <p:cNvPr id="32" name="Straight Connector 31"/>
            <p:cNvCxnSpPr/>
            <p:nvPr/>
          </p:nvCxnSpPr>
          <p:spPr>
            <a:xfrm>
              <a:off x="5136126" y="2332230"/>
              <a:ext cx="427703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Rectangle 32"/>
            <p:cNvSpPr/>
            <p:nvPr/>
          </p:nvSpPr>
          <p:spPr>
            <a:xfrm>
              <a:off x="5008202" y="2038907"/>
              <a:ext cx="683550" cy="3719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</a:rPr>
                <a:t>****</a:t>
              </a:r>
              <a:endParaRPr lang="en-US" sz="1200" dirty="0"/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530782" y="5655858"/>
            <a:ext cx="4594327" cy="2712768"/>
            <a:chOff x="4391418" y="2341304"/>
            <a:chExt cx="4415527" cy="3542408"/>
          </a:xfrm>
        </p:grpSpPr>
        <p:pic>
          <p:nvPicPr>
            <p:cNvPr id="35" name="Content Placeholder 3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73" t="6126" r="26689" b="11851"/>
            <a:stretch/>
          </p:blipFill>
          <p:spPr>
            <a:xfrm>
              <a:off x="4954040" y="2363144"/>
              <a:ext cx="3852905" cy="3520568"/>
            </a:xfrm>
            <a:prstGeom prst="rect">
              <a:avLst/>
            </a:prstGeom>
          </p:spPr>
        </p:pic>
        <p:sp>
          <p:nvSpPr>
            <p:cNvPr id="36" name="TextBox 35"/>
            <p:cNvSpPr txBox="1"/>
            <p:nvPr/>
          </p:nvSpPr>
          <p:spPr>
            <a:xfrm>
              <a:off x="4391418" y="2341304"/>
              <a:ext cx="354958" cy="234033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1200" b="1" dirty="0"/>
                <a:t>INFG  Score wo INFA genes</a:t>
              </a: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5219217" y="2493433"/>
              <a:ext cx="683550" cy="36171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</a:rPr>
                <a:t>****</a:t>
              </a:r>
              <a:endParaRPr lang="en-US" sz="1200" dirty="0"/>
            </a:p>
          </p:txBody>
        </p:sp>
        <p:cxnSp>
          <p:nvCxnSpPr>
            <p:cNvPr id="38" name="Straight Connector 37"/>
            <p:cNvCxnSpPr/>
            <p:nvPr/>
          </p:nvCxnSpPr>
          <p:spPr>
            <a:xfrm>
              <a:off x="5347141" y="2754261"/>
              <a:ext cx="427703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Rectangle 38"/>
            <p:cNvSpPr/>
            <p:nvPr/>
          </p:nvSpPr>
          <p:spPr>
            <a:xfrm>
              <a:off x="5646920" y="2862765"/>
              <a:ext cx="683550" cy="36171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</a:rPr>
                <a:t>****</a:t>
              </a:r>
              <a:endParaRPr lang="en-US" sz="1200" dirty="0"/>
            </a:p>
          </p:txBody>
        </p:sp>
        <p:cxnSp>
          <p:nvCxnSpPr>
            <p:cNvPr id="40" name="Straight Connector 39"/>
            <p:cNvCxnSpPr/>
            <p:nvPr/>
          </p:nvCxnSpPr>
          <p:spPr>
            <a:xfrm>
              <a:off x="5774844" y="3100092"/>
              <a:ext cx="427703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" name="TextBox 40"/>
          <p:cNvSpPr txBox="1"/>
          <p:nvPr/>
        </p:nvSpPr>
        <p:spPr>
          <a:xfrm>
            <a:off x="190624" y="8595200"/>
            <a:ext cx="303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.</a:t>
            </a:r>
          </a:p>
        </p:txBody>
      </p:sp>
      <p:grpSp>
        <p:nvGrpSpPr>
          <p:cNvPr id="42" name="Group 41"/>
          <p:cNvGrpSpPr/>
          <p:nvPr/>
        </p:nvGrpSpPr>
        <p:grpSpPr>
          <a:xfrm>
            <a:off x="722926" y="8451716"/>
            <a:ext cx="4698160" cy="3444911"/>
            <a:chOff x="3050875" y="1123629"/>
            <a:chExt cx="4607225" cy="4125380"/>
          </a:xfrm>
        </p:grpSpPr>
        <p:pic>
          <p:nvPicPr>
            <p:cNvPr id="43" name="Picture 42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88" r="25416" b="10527"/>
            <a:stretch/>
          </p:blipFill>
          <p:spPr>
            <a:xfrm>
              <a:off x="3420207" y="1123629"/>
              <a:ext cx="4237893" cy="4125380"/>
            </a:xfrm>
            <a:prstGeom prst="rect">
              <a:avLst/>
            </a:prstGeom>
          </p:spPr>
        </p:pic>
        <p:sp>
          <p:nvSpPr>
            <p:cNvPr id="44" name="Rectangle 43"/>
            <p:cNvSpPr/>
            <p:nvPr/>
          </p:nvSpPr>
          <p:spPr>
            <a:xfrm>
              <a:off x="3819832" y="1526279"/>
              <a:ext cx="683550" cy="33171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</a:rPr>
                <a:t>**</a:t>
              </a:r>
              <a:endParaRPr lang="en-US" sz="1200" dirty="0"/>
            </a:p>
          </p:txBody>
        </p:sp>
        <p:cxnSp>
          <p:nvCxnSpPr>
            <p:cNvPr id="45" name="Straight Connector 44"/>
            <p:cNvCxnSpPr/>
            <p:nvPr/>
          </p:nvCxnSpPr>
          <p:spPr>
            <a:xfrm>
              <a:off x="3896411" y="1804692"/>
              <a:ext cx="427703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 flipV="1">
              <a:off x="3896411" y="1995854"/>
              <a:ext cx="833851" cy="520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/>
            <p:cNvSpPr txBox="1"/>
            <p:nvPr/>
          </p:nvSpPr>
          <p:spPr>
            <a:xfrm>
              <a:off x="4110262" y="1741721"/>
              <a:ext cx="347721" cy="3317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</a:rPr>
                <a:t>NS</a:t>
              </a:r>
            </a:p>
          </p:txBody>
        </p:sp>
        <p:cxnSp>
          <p:nvCxnSpPr>
            <p:cNvPr id="48" name="Straight Connector 47"/>
            <p:cNvCxnSpPr/>
            <p:nvPr/>
          </p:nvCxnSpPr>
          <p:spPr>
            <a:xfrm flipV="1">
              <a:off x="3896411" y="2241656"/>
              <a:ext cx="1273466" cy="8161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/>
            <p:cNvSpPr txBox="1"/>
            <p:nvPr/>
          </p:nvSpPr>
          <p:spPr>
            <a:xfrm>
              <a:off x="4110262" y="1990485"/>
              <a:ext cx="381836" cy="3317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</a:rPr>
                <a:t>NS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050875" y="1602206"/>
              <a:ext cx="362183" cy="218846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1200" b="1" dirty="0"/>
                <a:t>TNFA  Score wo INFG genes</a:t>
              </a:r>
            </a:p>
          </p:txBody>
        </p:sp>
      </p:grpSp>
      <p:sp>
        <p:nvSpPr>
          <p:cNvPr id="51" name="TextBox 50">
            <a:extLst>
              <a:ext uri="{FF2B5EF4-FFF2-40B4-BE49-F238E27FC236}">
                <a16:creationId xmlns:a16="http://schemas.microsoft.com/office/drawing/2014/main" id="{905A1DB7-CF1C-3146-B1DD-6211A00A3CFA}"/>
              </a:ext>
            </a:extLst>
          </p:cNvPr>
          <p:cNvSpPr txBox="1"/>
          <p:nvPr/>
        </p:nvSpPr>
        <p:spPr>
          <a:xfrm>
            <a:off x="5245234" y="11527295"/>
            <a:ext cx="10264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L" dirty="0"/>
              <a:t>Figure 7s</a:t>
            </a:r>
          </a:p>
        </p:txBody>
      </p:sp>
    </p:spTree>
    <p:extLst>
      <p:ext uri="{BB962C8B-B14F-4D97-AF65-F5344CB8AC3E}">
        <p14:creationId xmlns:p14="http://schemas.microsoft.com/office/powerpoint/2010/main" val="14821618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E61126B9-FA1E-F545-B955-5E2D6761BAD5}"/>
              </a:ext>
            </a:extLst>
          </p:cNvPr>
          <p:cNvSpPr txBox="1"/>
          <p:nvPr/>
        </p:nvSpPr>
        <p:spPr>
          <a:xfrm>
            <a:off x="4802499" y="3753817"/>
            <a:ext cx="13617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/>
              <a:t>DNMT3A</a:t>
            </a:r>
            <a:r>
              <a:rPr lang="en-US" sz="1200" baseline="30000" dirty="0"/>
              <a:t>Mu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19195D3-F00B-E449-8CB5-3F4B7794E849}"/>
              </a:ext>
            </a:extLst>
          </p:cNvPr>
          <p:cNvSpPr txBox="1"/>
          <p:nvPr/>
        </p:nvSpPr>
        <p:spPr>
          <a:xfrm>
            <a:off x="383663" y="51511"/>
            <a:ext cx="426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200" dirty="0"/>
              <a:t>a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DB2BDEE-490F-1747-ADAD-6647E5BF5E63}"/>
              </a:ext>
            </a:extLst>
          </p:cNvPr>
          <p:cNvSpPr txBox="1"/>
          <p:nvPr/>
        </p:nvSpPr>
        <p:spPr>
          <a:xfrm>
            <a:off x="3727316" y="36824"/>
            <a:ext cx="435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200" dirty="0"/>
              <a:t>b.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1558816-7735-3E42-82BF-A9B2B0BFF37D}"/>
              </a:ext>
            </a:extLst>
          </p:cNvPr>
          <p:cNvSpPr txBox="1"/>
          <p:nvPr/>
        </p:nvSpPr>
        <p:spPr>
          <a:xfrm>
            <a:off x="403108" y="4287266"/>
            <a:ext cx="415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200" dirty="0"/>
              <a:t>c.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6E10D34-447B-2246-BD09-7F20D75A57C4}"/>
              </a:ext>
            </a:extLst>
          </p:cNvPr>
          <p:cNvSpPr txBox="1"/>
          <p:nvPr/>
        </p:nvSpPr>
        <p:spPr>
          <a:xfrm>
            <a:off x="1076058" y="3771694"/>
            <a:ext cx="13617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/>
              <a:t>DNMT3A</a:t>
            </a:r>
            <a:r>
              <a:rPr lang="en-US" sz="1200" baseline="30000" dirty="0"/>
              <a:t>W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E328372-AE23-D445-AF1A-3B88451D7148}"/>
              </a:ext>
            </a:extLst>
          </p:cNvPr>
          <p:cNvSpPr txBox="1"/>
          <p:nvPr/>
        </p:nvSpPr>
        <p:spPr>
          <a:xfrm>
            <a:off x="3727316" y="4287266"/>
            <a:ext cx="415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200" dirty="0"/>
              <a:t>d.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A7FD3367-FEE5-A344-8F09-3416F4091F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69442" y="4564265"/>
            <a:ext cx="3399922" cy="366203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0EE10E2A-6BEF-574D-AB31-6C19CC1E584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971" y="4564265"/>
            <a:ext cx="3399921" cy="366203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661074AD-9817-9A40-A3B0-A2135499EDA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2405" y="284146"/>
            <a:ext cx="3428999" cy="3365274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2D394827-E9F4-C945-9542-F423A8EE0D8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73440" y="306338"/>
            <a:ext cx="3104870" cy="3404219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AA95EAA-12D6-B643-B455-1D13356A0C6B}"/>
              </a:ext>
            </a:extLst>
          </p:cNvPr>
          <p:cNvSpPr txBox="1"/>
          <p:nvPr/>
        </p:nvSpPr>
        <p:spPr>
          <a:xfrm>
            <a:off x="3208858" y="9645464"/>
            <a:ext cx="10264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L"/>
              <a:t>Figure 8s</a:t>
            </a:r>
            <a:endParaRPr lang="en-IL" dirty="0"/>
          </a:p>
        </p:txBody>
      </p:sp>
    </p:spTree>
    <p:extLst>
      <p:ext uri="{BB962C8B-B14F-4D97-AF65-F5344CB8AC3E}">
        <p14:creationId xmlns:p14="http://schemas.microsoft.com/office/powerpoint/2010/main" val="3535090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38</TotalTime>
  <Words>244</Words>
  <Application>Microsoft Macintosh PowerPoint</Application>
  <PresentationFormat>Widescreen</PresentationFormat>
  <Paragraphs>95</Paragraphs>
  <Slides>8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ran Shlush</dc:creator>
  <cp:lastModifiedBy>Nathali Kaushansky</cp:lastModifiedBy>
  <cp:revision>60</cp:revision>
  <dcterms:created xsi:type="dcterms:W3CDTF">2021-08-24T05:59:27Z</dcterms:created>
  <dcterms:modified xsi:type="dcterms:W3CDTF">2021-10-07T12:55:25Z</dcterms:modified>
</cp:coreProperties>
</file>